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8A5325-8878-E1FF-27C1-F84C1CBEEA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D85729F-7A10-08AE-9346-5B08FF6C54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DA24AE-70D0-6F7D-2A41-DCF0C7DA6C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DC21694-6CC8-946E-E783-3A791AF1E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3D99D5-83BC-B44B-4F94-6D3273F8A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2178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906001-C19F-80B2-EA61-44C9A63C2E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273C107-A45D-BE8E-B1D7-E6D4937308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79E69A-03FD-8868-12B8-9182256D38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5DB030-B082-86ED-65A6-0E8786CEA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D163DC-BF3D-AC7C-9235-E4F1B6B129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9111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3B1B54C-73D9-5A70-7E51-4DA5D58B64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343B5A2-8AE7-E783-D4CF-78D78DC798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BA9DC6-FACC-AFCD-C377-F8F7FB5C09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7FD7090-841F-F189-148B-6BE8AACAA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5DC6FA-40E0-343E-06D2-60E7EC9314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7706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347D62-B37A-2115-1B8B-140F1C3FA7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E7C22C5-4932-7D14-9BB1-3D122D44D0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8CC4F6-D97F-C730-6539-08D8DF0DC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C8EC7F-F593-2881-6DA0-C04BFDD67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EE6D2B-7BEA-EA8D-1B9F-EC10715F9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5109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EBFA42-B4E0-0469-B47A-782C4E92BD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D26CE8E-D53F-D19D-AFEE-003A084C01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FDFD24-AD60-B209-EE63-34910750C1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D348F89-FA71-DE35-60F6-E3B2E69A4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B4937B-4983-1E7D-6190-690C0A1D71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8216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7ACAA2-7544-3E8F-7D6F-3D0960230C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B1C73B7-0E36-6B8A-1CF5-8E8AC120FF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041DF71-6410-EBA8-1BB0-F25C4B3ABB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472AAEB-5EBC-1C06-BBC0-F9455BEB1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60651B7-3CB3-7B38-2EE2-8A2DDABA8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2173F47-5832-D29A-79B0-458D80718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0379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E0FB8D-453A-9E50-D9F9-76BB9014D7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7E6F35D-0F16-37BB-25F7-2857D39F8A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7898EA6-0224-6FC3-BD43-003AA84349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609AD26-C7CF-BE4A-B4C2-ED74B15BF3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84B62D3-EE71-6409-A50E-F445733E8E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5D1044A-0286-C982-4D34-BC77684A7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9A7D6EC-6B8F-9117-0559-1C8F932221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889C73E-A8D0-6696-843B-085C557AF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6167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1A467B-5BD7-AA6F-D9CC-E5F08997AB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7BBA676-34CA-A2F4-04F9-B0EB9B5D2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2638150-29B6-A1D0-2745-9F0CDCBA42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0C103C3-1E57-1247-074D-7C2D33868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8289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AB8E7DC-5418-482A-65E0-E2121263D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E3022F6-3BC7-32E6-FF81-437380BB0D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3A57E7C-A54A-7C5D-A844-1A90BDE7A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7771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2664D8-5B77-F61C-1720-AC0F309FB2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97E50A-983B-7F0A-6417-198246F434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F63EDAB-3AE6-8475-06E0-B645740653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3677230-6D57-CF96-BEDC-1E0887747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352FF7-F1C0-3803-BDBF-198B328C7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5915BA3-FD7B-F2CF-9978-2364048B9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2139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DAB0BE-385B-FF53-5007-941641A8EC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97C127B-D3D5-39E6-3435-4F2ED6FD47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A4EF115-A2D0-32D9-F224-ACA42DC75B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DBDCAED-7285-B3BF-A122-FA2805620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FFF8BF2-7919-22E6-E153-E41E6F79E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D768CD7-9BCD-975A-36CF-EF0BEB154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5698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687ED54-2893-F68C-02AE-DF0BF61DCF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E391927-ACBE-F4CF-37F4-C90C50DDC6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5EE3A8-39EF-E20D-20B8-1D93CCE801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E2DE48-0007-4B79-BC2F-7097DD18757F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62F24A7-8315-BDDE-3691-FFC04296C4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B0F3A9-237B-7F74-99DE-F07269A527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02F8EB-BFDC-485C-BEB8-93CB88558C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412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文本框 29">
            <a:extLst>
              <a:ext uri="{FF2B5EF4-FFF2-40B4-BE49-F238E27FC236}">
                <a16:creationId xmlns:a16="http://schemas.microsoft.com/office/drawing/2014/main" id="{E722F7A6-51DA-59FC-6568-5D37F18C31F8}"/>
              </a:ext>
            </a:extLst>
          </p:cNvPr>
          <p:cNvSpPr txBox="1"/>
          <p:nvPr/>
        </p:nvSpPr>
        <p:spPr>
          <a:xfrm>
            <a:off x="85523" y="0"/>
            <a:ext cx="60984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ublished data in Figure 2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7888D438-B5BE-D292-7E1F-5B06B7489C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7253" y="807493"/>
            <a:ext cx="6157494" cy="52430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5728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159B03ED-8317-CAF2-8CA2-2D792A6B27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3415613"/>
              </p:ext>
            </p:extLst>
          </p:nvPr>
        </p:nvGraphicFramePr>
        <p:xfrm>
          <a:off x="674703" y="461638"/>
          <a:ext cx="11461072" cy="629206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55938">
                  <a:extLst>
                    <a:ext uri="{9D8B030D-6E8A-4147-A177-3AD203B41FA5}">
                      <a16:colId xmlns:a16="http://schemas.microsoft.com/office/drawing/2014/main" val="3181122969"/>
                    </a:ext>
                  </a:extLst>
                </a:gridCol>
                <a:gridCol w="1229960">
                  <a:extLst>
                    <a:ext uri="{9D8B030D-6E8A-4147-A177-3AD203B41FA5}">
                      <a16:colId xmlns:a16="http://schemas.microsoft.com/office/drawing/2014/main" val="830289805"/>
                    </a:ext>
                  </a:extLst>
                </a:gridCol>
                <a:gridCol w="961209">
                  <a:extLst>
                    <a:ext uri="{9D8B030D-6E8A-4147-A177-3AD203B41FA5}">
                      <a16:colId xmlns:a16="http://schemas.microsoft.com/office/drawing/2014/main" val="2343602663"/>
                    </a:ext>
                  </a:extLst>
                </a:gridCol>
                <a:gridCol w="961209">
                  <a:extLst>
                    <a:ext uri="{9D8B030D-6E8A-4147-A177-3AD203B41FA5}">
                      <a16:colId xmlns:a16="http://schemas.microsoft.com/office/drawing/2014/main" val="1136486272"/>
                    </a:ext>
                  </a:extLst>
                </a:gridCol>
                <a:gridCol w="1313720">
                  <a:extLst>
                    <a:ext uri="{9D8B030D-6E8A-4147-A177-3AD203B41FA5}">
                      <a16:colId xmlns:a16="http://schemas.microsoft.com/office/drawing/2014/main" val="3680107957"/>
                    </a:ext>
                  </a:extLst>
                </a:gridCol>
                <a:gridCol w="718461">
                  <a:extLst>
                    <a:ext uri="{9D8B030D-6E8A-4147-A177-3AD203B41FA5}">
                      <a16:colId xmlns:a16="http://schemas.microsoft.com/office/drawing/2014/main" val="1426621995"/>
                    </a:ext>
                  </a:extLst>
                </a:gridCol>
                <a:gridCol w="851447">
                  <a:extLst>
                    <a:ext uri="{9D8B030D-6E8A-4147-A177-3AD203B41FA5}">
                      <a16:colId xmlns:a16="http://schemas.microsoft.com/office/drawing/2014/main" val="2179020790"/>
                    </a:ext>
                  </a:extLst>
                </a:gridCol>
                <a:gridCol w="961209">
                  <a:extLst>
                    <a:ext uri="{9D8B030D-6E8A-4147-A177-3AD203B41FA5}">
                      <a16:colId xmlns:a16="http://schemas.microsoft.com/office/drawing/2014/main" val="3697471442"/>
                    </a:ext>
                  </a:extLst>
                </a:gridCol>
                <a:gridCol w="961209">
                  <a:extLst>
                    <a:ext uri="{9D8B030D-6E8A-4147-A177-3AD203B41FA5}">
                      <a16:colId xmlns:a16="http://schemas.microsoft.com/office/drawing/2014/main" val="1845980976"/>
                    </a:ext>
                  </a:extLst>
                </a:gridCol>
                <a:gridCol w="961209">
                  <a:extLst>
                    <a:ext uri="{9D8B030D-6E8A-4147-A177-3AD203B41FA5}">
                      <a16:colId xmlns:a16="http://schemas.microsoft.com/office/drawing/2014/main" val="1647280783"/>
                    </a:ext>
                  </a:extLst>
                </a:gridCol>
                <a:gridCol w="1085501">
                  <a:extLst>
                    <a:ext uri="{9D8B030D-6E8A-4147-A177-3AD203B41FA5}">
                      <a16:colId xmlns:a16="http://schemas.microsoft.com/office/drawing/2014/main" val="1065677502"/>
                    </a:ext>
                  </a:extLst>
                </a:gridCol>
              </a:tblGrid>
              <a:tr h="227387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716809994"/>
                  </a:ext>
                </a:extLst>
              </a:tr>
              <a:tr h="448203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772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957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379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645220604"/>
                  </a:ext>
                </a:extLst>
              </a:tr>
              <a:tr h="227387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191439125"/>
                  </a:ext>
                </a:extLst>
              </a:tr>
              <a:tr h="448103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05416002"/>
                  </a:ext>
                </a:extLst>
              </a:tr>
              <a:tr h="44820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pase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05.209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77.86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7.67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5.806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-8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86.21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03.509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02.00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94.97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88998091"/>
                  </a:ext>
                </a:extLst>
              </a:tr>
              <a:tr h="227387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760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3689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9709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572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479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4056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364253157"/>
                  </a:ext>
                </a:extLst>
              </a:tr>
              <a:tr h="44810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-3/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1701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537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301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-8/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752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6866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84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537330013"/>
                  </a:ext>
                </a:extLst>
              </a:tr>
              <a:tr h="227387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742213803"/>
                  </a:ext>
                </a:extLst>
              </a:tr>
              <a:tr h="448103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003116114"/>
                  </a:ext>
                </a:extLst>
              </a:tr>
              <a:tr h="2273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pase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7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37.8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18.0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77.856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9.2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pase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9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40.39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98.586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40.13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1.07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545919056"/>
                  </a:ext>
                </a:extLst>
              </a:tr>
              <a:tr h="227387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618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36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191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364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244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8954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992404637"/>
                  </a:ext>
                </a:extLst>
              </a:tr>
              <a:tr h="227387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571511058"/>
                  </a:ext>
                </a:extLst>
              </a:tr>
              <a:tr h="44810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-7/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924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572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126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-9/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897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3883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809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292627865"/>
                  </a:ext>
                </a:extLst>
              </a:tr>
              <a:tr h="227387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285432506"/>
                  </a:ext>
                </a:extLst>
              </a:tr>
              <a:tr h="448103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935015601"/>
                  </a:ext>
                </a:extLst>
              </a:tr>
              <a:tr h="227387"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ARP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18.87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45.996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68.86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1.91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eaved-PARP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6.2106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93.39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35.71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24117026"/>
                  </a:ext>
                </a:extLst>
              </a:tr>
              <a:tr h="227387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660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4188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3584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2882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669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105348695"/>
                  </a:ext>
                </a:extLst>
              </a:tr>
              <a:tr h="227387"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99245337"/>
                  </a:ext>
                </a:extLst>
              </a:tr>
              <a:tr h="44820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P/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2006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2295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4473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eaved-</a:t>
                      </a:r>
                    </a:p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P/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4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6961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8037</a:t>
                      </a:r>
                      <a:endParaRPr lang="en-US" altLang="zh-CN" sz="14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0903</a:t>
                      </a:r>
                      <a:endParaRPr lang="en-US" altLang="zh-CN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769961398"/>
                  </a:ext>
                </a:extLst>
              </a:tr>
            </a:tbl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E5DD39B0-29FE-2BE0-FD2E-D382AE02108D}"/>
              </a:ext>
            </a:extLst>
          </p:cNvPr>
          <p:cNvSpPr txBox="1"/>
          <p:nvPr/>
        </p:nvSpPr>
        <p:spPr>
          <a:xfrm>
            <a:off x="161723" y="0"/>
            <a:ext cx="60984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aw data for Fig 2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9787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45</Words>
  <Application>Microsoft Office PowerPoint</Application>
  <PresentationFormat>宽屏</PresentationFormat>
  <Paragraphs>11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007</dc:creator>
  <cp:lastModifiedBy>007</cp:lastModifiedBy>
  <cp:revision>8</cp:revision>
  <dcterms:created xsi:type="dcterms:W3CDTF">2022-06-10T07:26:46Z</dcterms:created>
  <dcterms:modified xsi:type="dcterms:W3CDTF">2025-10-02T12:12:05Z</dcterms:modified>
</cp:coreProperties>
</file>